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bert Chemelewski" initials="RC" lastIdx="1" clrIdx="0">
    <p:extLst>
      <p:ext uri="{19B8F6BF-5375-455C-9EA6-DF929625EA0E}">
        <p15:presenceInfo xmlns:p15="http://schemas.microsoft.com/office/powerpoint/2012/main" userId="e8a550d334cd12d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6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A0097-5800-AB37-37C1-7A193ABEF9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7A1522-ECB2-AB1B-4719-41C68B6423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10EEEC-852D-86EE-E0B4-8EDD0C82A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3F7D8-5864-4E51-BE08-03C56C2DB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8D0165-241F-F934-6695-5EC66264E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333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643EC5-A59F-0866-312D-AE200F04E8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AAE128-2ABE-69F9-455F-298B36C850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4438A3-631D-A3A1-A742-BE479AE5E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CF3D18-0616-64A1-22F3-CD69371FF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628931-C5A0-4DB5-F717-A1B7FF08E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226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BC91D0-DAB5-3556-B6A2-0ADE6E7A41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649C1F-4B7A-7D97-68F1-92FE7A9634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EC7E26-3F51-4D73-E973-B9508A0E8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184EAF-FD32-62F6-B082-4CEF0B67B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522BA8-487B-1825-C10D-BCFBAD33C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429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429981-C582-B30D-EDE9-6B430B7A1E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195D94-9E4E-03B5-393C-97CD62FC7E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31C74F-ACD8-3850-330E-9E98AD70E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B33387-0AF5-A511-A33E-264B29433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E61FD8-A21D-02D9-E0E5-21B0FB0EA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132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873963-37AA-71B3-7EBF-32462D1CC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68C44E-A601-6DF5-FC3E-BB2959A012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90A5CC-F4F3-37A7-EF92-55C4B4E70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A3371F-4703-01B9-D6E5-C4C901563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127EF-88A6-0394-FA8B-992E48F68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876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0FFF8F-5E5D-11C0-A4BD-E23F517FD9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41D02B-629C-B895-0623-3ECF856EF1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7A3C41-7877-366F-D221-5BB8EFFB36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A941D4-C72A-1811-23B9-626B24849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4A09CD-5039-D5F9-3B29-261C6328D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0EC745-DCF2-69B3-4DBA-C5DE039D6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376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E69C2-7AF2-AB10-2AB8-46D0EA924A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C03C01-F7A1-6672-CE9F-FE3D5F2080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8BD65A-E212-BA28-0511-D036D90EEA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0BF4D3-BB4D-02C7-A91C-C1B5F11A8D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86987F-3AA3-05C5-105C-9DAAA8A9AF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C2D4C5-1FDD-42BA-FA84-F4C272C10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68F2CB-CAA6-F214-CCEE-6E1DF007A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9CA7CF-1BDA-600A-9CBA-B7DE681BA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224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E58D3-441E-9371-E1A3-0900367C4E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DD9C29-2D63-2C70-E358-13AB19E74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107224-AEFF-2019-9AE5-B44BEB552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A77B19-57F3-5848-AE40-856035BD4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94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36466D-6116-F6F9-EE6D-CE32EDD43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137B97-E4B5-20C4-2A78-09E21798F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F6B42A-AD18-CABE-E59F-06A0101B7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962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C6A3CB-EF09-8F3E-B80A-E873FFB66B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B45849-36BD-F2F0-56F5-FF16FDAC8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350153-CAB3-2D12-378A-3BDB648ED1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0E3D73-215B-0A29-6A80-B8778DB1B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EBFCB2-8EAE-F05D-F00E-0DAFE542F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D70BC-AE19-1ABC-6EEF-B590D627F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751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63285-3151-F62F-3DAC-347E593EF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D0988E-674E-3529-C119-EE57F62FB0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62B05E-07C2-C50F-4085-B0290E73AF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D1CFBD-43E5-7FDA-7C3C-EBC7490F3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1FF09-3492-9358-13A1-6E8F611C0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C287E0-948A-6A5F-1852-BD840193E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664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9D0350-6BBB-0324-E14B-C570583935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707A77-29E0-00F4-4191-20A8DF42F1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2F6BC-AEBF-710A-671D-931FD00DCA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4911AA-B51F-427C-BEF0-2610E0E6B108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A4FFEF-0ECB-D3FC-85AA-EF2D0085A0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EFCB79-A4B8-D9C8-93CA-7BA4AC2841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C39C0-C3A9-4DCC-A7A0-CA49B10353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169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A5F7FF-5AAC-46F8-A05F-1652F81E00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/>
              <a:t>Supplemental Figure 9 </a:t>
            </a:r>
            <a:r>
              <a:rPr lang="en-US" dirty="0"/>
              <a:t>CER6 (start of biosynthetic pathway) and WSD1 (unique wax biosynthesis gene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DDCEE30-C325-4F36-8180-082E71F1DF5E}"/>
              </a:ext>
            </a:extLst>
          </p:cNvPr>
          <p:cNvSpPr/>
          <p:nvPr/>
        </p:nvSpPr>
        <p:spPr>
          <a:xfrm>
            <a:off x="4581525" y="2636888"/>
            <a:ext cx="247650" cy="872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4A814BE-4005-41A7-8751-4821BDD55019}"/>
              </a:ext>
            </a:extLst>
          </p:cNvPr>
          <p:cNvSpPr/>
          <p:nvPr/>
        </p:nvSpPr>
        <p:spPr>
          <a:xfrm>
            <a:off x="4581525" y="4925268"/>
            <a:ext cx="247650" cy="872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2D3F0F5-3F12-47B6-B232-32E2264B9B5A}"/>
              </a:ext>
            </a:extLst>
          </p:cNvPr>
          <p:cNvSpPr txBox="1"/>
          <p:nvPr/>
        </p:nvSpPr>
        <p:spPr>
          <a:xfrm>
            <a:off x="4521526" y="2579885"/>
            <a:ext cx="51648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dirty="0"/>
              <a:t>Transcript I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CA0B48C-0A09-434F-AD76-BBFC680301FC}"/>
              </a:ext>
            </a:extLst>
          </p:cNvPr>
          <p:cNvSpPr txBox="1"/>
          <p:nvPr/>
        </p:nvSpPr>
        <p:spPr>
          <a:xfrm>
            <a:off x="1721403" y="164714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en-US" sz="24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A42C9B9-ECA8-47E4-B085-6A4C98BE4170}"/>
              </a:ext>
            </a:extLst>
          </p:cNvPr>
          <p:cNvSpPr txBox="1"/>
          <p:nvPr/>
        </p:nvSpPr>
        <p:spPr>
          <a:xfrm>
            <a:off x="1721403" y="397691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en-US" sz="2400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A59291C-CFB9-381A-9F89-E73C2C82A4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5531" y="1831811"/>
            <a:ext cx="3267485" cy="203746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CADBE2F-40DF-204A-DDBA-85BFA28E90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37144" y="1831811"/>
            <a:ext cx="3267487" cy="203746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DF0E0C3-5C30-7A2F-078E-408E01804A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45532" y="4161580"/>
            <a:ext cx="3267484" cy="203746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5E7620C-CA95-9D5F-0EFB-1C6BA9E40B3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37144" y="4161580"/>
            <a:ext cx="3267484" cy="20374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6493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9 CER6 (start of biosynthetic pathway) and WSD1 (unique wax biosynthesis gene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Chemelewski</dc:creator>
  <cp:lastModifiedBy>Abby Rassette</cp:lastModifiedBy>
  <cp:revision>5</cp:revision>
  <dcterms:created xsi:type="dcterms:W3CDTF">2023-05-23T18:35:33Z</dcterms:created>
  <dcterms:modified xsi:type="dcterms:W3CDTF">2023-09-11T14:26:14Z</dcterms:modified>
</cp:coreProperties>
</file>